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B94A1F8-AC25-C420-4ACE-3A7C8EEB55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B9C63247-128E-15ED-0754-E2BA76BF11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58FE368-8C33-E7B5-16E3-28B75EA89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5E9FA301-904C-3AC8-09DC-D80D47872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1CD026B-83CC-E751-13DA-1B24C1A09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82515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12AA318-8AD1-E6AB-8380-9C44C829B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E7934242-CB1C-63CA-F75F-7E9DF79928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50B4B00-3C92-AAF7-B849-666FB5740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52CB5CC7-3D88-F397-42B3-5954BEB93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0E0D9FF-A59C-C76E-20BD-722370AB7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32972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0333D608-90BA-DF9B-713A-43AEED8D27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2890006C-4A27-24CF-2C71-F1D3097191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89EACEF9-4D7B-3E78-F9DB-11CAD134D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24FE2A7-75A6-A924-E48F-0EBF46D05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A710736-90F1-3778-6E78-D05810E9A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0678873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0B0F9DF-EDD6-CBEF-305B-490F01C46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4DAE4C07-0FF5-C835-2663-0D5D1B434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1B78802-EA07-F506-D109-E9D9EE28B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4AD4B61-F3EF-1499-B9F0-D94B18CBC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E6E7A81-E5B6-14F9-6493-0F4DA7806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11699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CBF225E-17E9-C493-9F70-5547997752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6C56EE4C-63DA-BD24-2D45-008A56B87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CE72E0B-3551-50A2-8CA1-BBD62A28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A86C7C3-333C-BB62-E83F-7935F44C2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1D03E146-885B-4B7B-20F9-0AE77905D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45284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6E88294-7250-0EC7-33FE-BDBB2CEF0C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699182B6-1CDD-03B4-3499-21DBB71AC6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9861A0D2-1B36-7962-F22D-6D266A8673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2713C070-3730-1A2A-D7D3-19CE5CDCF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4AEAF760-CE71-1843-696B-A6F4AACB5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87F7B36-78E2-2FA7-5109-7F6858EF4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64840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50EFB2B-25ED-0484-68EC-42C185DA44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7604F36E-78FF-6C5D-67F0-81EC21B241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1272D195-E951-F9B3-427C-9DE279CFBE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324B4BBE-F43E-B574-39D7-1298BDE1B0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8432921B-8F23-50EB-88DC-DFD748D49C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54D39A6D-0D64-F100-3BC4-17D6D9008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C8ADC752-0DAA-03EE-1882-F012520DB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F4D7F3F8-C4A2-E52A-D31C-11E362D64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0512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9D937BC-40A3-E6AC-FCF7-5E709F916F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D9CA5140-3043-B4AF-A86B-658827A81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EC924F40-55CC-37A9-606E-2801AF648D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5CC8DC3F-982F-B12A-6C9D-2BE132FF1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95626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BC2516E1-A242-5D2C-EB2C-2431A6129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1F87C8F7-517C-AD4E-3A97-5AA622794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95EB5766-8FBB-BC93-CCB8-B6FAC2259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995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F2BB42F-A800-696E-EF71-699017B8AB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1FE082A-C8BA-19AD-98DC-E925CD37A2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51DD4D93-0970-8F93-761A-93749FD20C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43EEF93-0AA8-9223-901B-3C98B4CFF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C34CE5A-7436-BA10-8BF7-4368414E78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BC93D4F6-684B-ED36-6C3F-003F24960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16460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B07B0D0-25CF-DFF0-DA36-A8D4F4D2B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128EE1A8-6D48-2FE0-CCC6-4CF4D5D561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C0799CAC-BE21-5B29-A49E-386439F187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C6C745B6-0CBE-BFC9-2855-B53B738A88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917D0D92-38F4-1263-E77D-B6ADB2C3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410F2E2-88B2-FFEE-33FA-26DB3A3FA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683363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BDD19389-40F8-DD1F-ACEA-02F370F3D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4738F15-5C90-A60F-65AA-3076D54CD0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D49609D1-151B-60A3-92DD-871F8F2C59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DB4D8-20EF-46CD-8C88-B6B565FA6417}" type="datetimeFigureOut">
              <a:rPr lang="hu-HU" smtClean="0"/>
              <a:t>2023. 10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EA4D80C-A205-1185-4FED-EB2DB367F9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F35B05E-C04C-260A-F031-3371713DD1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E0B00-C9EA-4937-B316-0E63BB1EF85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87829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Kép 5" descr="A képen szöveg, képernyőkép, Betűtípus, sor látható">
            <a:extLst>
              <a:ext uri="{FF2B5EF4-FFF2-40B4-BE49-F238E27FC236}">
                <a16:creationId xmlns:a16="http://schemas.microsoft.com/office/drawing/2014/main" id="{7A9F66D3-982B-CF09-7B46-0027523F572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429" y="490855"/>
            <a:ext cx="5054215" cy="4595495"/>
          </a:xfrm>
          <a:prstGeom prst="rect">
            <a:avLst/>
          </a:prstGeom>
        </p:spPr>
      </p:pic>
      <p:sp>
        <p:nvSpPr>
          <p:cNvPr id="7" name="Szövegdoboz 6">
            <a:extLst>
              <a:ext uri="{FF2B5EF4-FFF2-40B4-BE49-F238E27FC236}">
                <a16:creationId xmlns:a16="http://schemas.microsoft.com/office/drawing/2014/main" id="{56E4ECCB-09A0-8D23-1058-C649D9BA152C}"/>
              </a:ext>
            </a:extLst>
          </p:cNvPr>
          <p:cNvSpPr txBox="1"/>
          <p:nvPr/>
        </p:nvSpPr>
        <p:spPr>
          <a:xfrm>
            <a:off x="6299424" y="490855"/>
            <a:ext cx="4531333" cy="42043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8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A. Phylogenetic comparison of Nicotiana PAO2-coding gene sequences by the Neighbour-Joining method. For sequence accessions see Table 1 and Suplementary table 3. B. Nucleotide sequence identitity values (%) (with gap% in parentheses). NTAB: </a:t>
            </a:r>
            <a:r>
              <a:rPr lang="en-GB" sz="1800" i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tabacum</a:t>
            </a:r>
            <a:r>
              <a:rPr lang="en-GB" sz="18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NSYLV: </a:t>
            </a:r>
            <a:r>
              <a:rPr lang="en-GB" sz="1800" i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sylvestris</a:t>
            </a:r>
            <a:r>
              <a:rPr lang="en-GB" sz="18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NTOM: </a:t>
            </a:r>
            <a:r>
              <a:rPr lang="en-GB" sz="1800" i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tomentosiformis</a:t>
            </a:r>
            <a:r>
              <a:rPr lang="en-GB" sz="18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NOTO: </a:t>
            </a:r>
            <a:r>
              <a:rPr lang="en-GB" sz="1800" i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. otophora</a:t>
            </a:r>
            <a:r>
              <a:rPr lang="en-GB" sz="18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</a:t>
            </a:r>
            <a:br>
              <a:rPr lang="en-GB" sz="180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91611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8</Words>
  <Application>Microsoft Office PowerPoint</Application>
  <PresentationFormat>Szélesvásznú</PresentationFormat>
  <Paragraphs>1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Fehér Attila Dr.</dc:creator>
  <cp:lastModifiedBy>Fehér Attila Dr.</cp:lastModifiedBy>
  <cp:revision>1</cp:revision>
  <dcterms:created xsi:type="dcterms:W3CDTF">2023-10-19T13:43:19Z</dcterms:created>
  <dcterms:modified xsi:type="dcterms:W3CDTF">2023-10-19T13:46:25Z</dcterms:modified>
</cp:coreProperties>
</file>